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37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54ED1AD-12F6-4911-AB54-DC191AC9BCCE}" type="datetimeFigureOut">
              <a:rPr lang="en-US" smtClean="0"/>
              <a:t>9/3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CA3A3D7-A0E3-4425-98D1-FEE4969D41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26706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C0CD22-8C53-498D-A322-06C01DABB0BA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620360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5F75B5-CEB3-4CAA-A499-683A9E08CB1C}" type="datetimeFigureOut">
              <a:rPr lang="en-US" smtClean="0"/>
              <a:t>9/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7FB66-91A5-45F8-8968-6562B75715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20028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5F75B5-CEB3-4CAA-A499-683A9E08CB1C}" type="datetimeFigureOut">
              <a:rPr lang="en-US" smtClean="0"/>
              <a:t>9/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7FB66-91A5-45F8-8968-6562B75715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11208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5F75B5-CEB3-4CAA-A499-683A9E08CB1C}" type="datetimeFigureOut">
              <a:rPr lang="en-US" smtClean="0"/>
              <a:t>9/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7FB66-91A5-45F8-8968-6562B75715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57462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5F75B5-CEB3-4CAA-A499-683A9E08CB1C}" type="datetimeFigureOut">
              <a:rPr lang="en-US" smtClean="0"/>
              <a:t>9/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7FB66-91A5-45F8-8968-6562B75715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08224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5F75B5-CEB3-4CAA-A499-683A9E08CB1C}" type="datetimeFigureOut">
              <a:rPr lang="en-US" smtClean="0"/>
              <a:t>9/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7FB66-91A5-45F8-8968-6562B75715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14493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5F75B5-CEB3-4CAA-A499-683A9E08CB1C}" type="datetimeFigureOut">
              <a:rPr lang="en-US" smtClean="0"/>
              <a:t>9/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7FB66-91A5-45F8-8968-6562B75715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93554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5F75B5-CEB3-4CAA-A499-683A9E08CB1C}" type="datetimeFigureOut">
              <a:rPr lang="en-US" smtClean="0"/>
              <a:t>9/3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7FB66-91A5-45F8-8968-6562B75715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24376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5F75B5-CEB3-4CAA-A499-683A9E08CB1C}" type="datetimeFigureOut">
              <a:rPr lang="en-US" smtClean="0"/>
              <a:t>9/3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7FB66-91A5-45F8-8968-6562B75715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11352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5F75B5-CEB3-4CAA-A499-683A9E08CB1C}" type="datetimeFigureOut">
              <a:rPr lang="en-US" smtClean="0"/>
              <a:t>9/3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7FB66-91A5-45F8-8968-6562B75715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35459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5F75B5-CEB3-4CAA-A499-683A9E08CB1C}" type="datetimeFigureOut">
              <a:rPr lang="en-US" smtClean="0"/>
              <a:t>9/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7FB66-91A5-45F8-8968-6562B75715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65669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5F75B5-CEB3-4CAA-A499-683A9E08CB1C}" type="datetimeFigureOut">
              <a:rPr lang="en-US" smtClean="0"/>
              <a:t>9/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7FB66-91A5-45F8-8968-6562B75715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10621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5F75B5-CEB3-4CAA-A499-683A9E08CB1C}" type="datetimeFigureOut">
              <a:rPr lang="en-US" smtClean="0"/>
              <a:t>9/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17FB66-91A5-45F8-8968-6562B75715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56915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1882140" y="2447167"/>
            <a:ext cx="8857818" cy="577081"/>
            <a:chOff x="2510264" y="3562146"/>
            <a:chExt cx="11810424" cy="769441"/>
          </a:xfrm>
        </p:grpSpPr>
        <p:grpSp>
          <p:nvGrpSpPr>
            <p:cNvPr id="5" name="Group 4"/>
            <p:cNvGrpSpPr/>
            <p:nvPr/>
          </p:nvGrpSpPr>
          <p:grpSpPr>
            <a:xfrm>
              <a:off x="4563322" y="3642572"/>
              <a:ext cx="9757366" cy="577812"/>
              <a:chOff x="4563322" y="3642572"/>
              <a:chExt cx="9757366" cy="577812"/>
            </a:xfrm>
          </p:grpSpPr>
          <p:sp>
            <p:nvSpPr>
              <p:cNvPr id="52" name="Rectangle 51"/>
              <p:cNvSpPr/>
              <p:nvPr/>
            </p:nvSpPr>
            <p:spPr>
              <a:xfrm>
                <a:off x="4563322" y="3644320"/>
                <a:ext cx="9757366" cy="57606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" name="Rectangle 52"/>
              <p:cNvSpPr/>
              <p:nvPr/>
            </p:nvSpPr>
            <p:spPr>
              <a:xfrm>
                <a:off x="6975872" y="3642572"/>
                <a:ext cx="3816424" cy="577812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Rectangle 53"/>
              <p:cNvSpPr/>
              <p:nvPr/>
            </p:nvSpPr>
            <p:spPr>
              <a:xfrm>
                <a:off x="6975872" y="3642572"/>
                <a:ext cx="1008112" cy="577812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62" name="TextBox 61"/>
            <p:cNvSpPr txBox="1"/>
            <p:nvPr/>
          </p:nvSpPr>
          <p:spPr>
            <a:xfrm>
              <a:off x="2510264" y="3562146"/>
              <a:ext cx="2005152" cy="769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rtl="0"/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Reduced secondary recombinant </a:t>
              </a:r>
            </a:p>
            <a:p>
              <a:pPr algn="ctr" rtl="0"/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(type a, R-10)</a:t>
              </a:r>
            </a:p>
          </p:txBody>
        </p:sp>
      </p:grpSp>
      <p:grpSp>
        <p:nvGrpSpPr>
          <p:cNvPr id="7" name="Group 6"/>
          <p:cNvGrpSpPr/>
          <p:nvPr/>
        </p:nvGrpSpPr>
        <p:grpSpPr>
          <a:xfrm>
            <a:off x="2137669" y="1662320"/>
            <a:ext cx="8602847" cy="435970"/>
            <a:chOff x="2850226" y="2843807"/>
            <a:chExt cx="11470462" cy="581293"/>
          </a:xfrm>
        </p:grpSpPr>
        <p:sp>
          <p:nvSpPr>
            <p:cNvPr id="61" name="TextBox 60"/>
            <p:cNvSpPr txBox="1"/>
            <p:nvPr/>
          </p:nvSpPr>
          <p:spPr>
            <a:xfrm>
              <a:off x="2850226" y="2871103"/>
              <a:ext cx="1388596" cy="553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rtl="0"/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Primary recombinant</a:t>
              </a:r>
            </a:p>
          </p:txBody>
        </p:sp>
        <p:grpSp>
          <p:nvGrpSpPr>
            <p:cNvPr id="6" name="Group 5"/>
            <p:cNvGrpSpPr/>
            <p:nvPr/>
          </p:nvGrpSpPr>
          <p:grpSpPr>
            <a:xfrm>
              <a:off x="4563322" y="2843807"/>
              <a:ext cx="9757366" cy="577813"/>
              <a:chOff x="4563322" y="2843807"/>
              <a:chExt cx="9757366" cy="577813"/>
            </a:xfrm>
          </p:grpSpPr>
          <p:sp>
            <p:nvSpPr>
              <p:cNvPr id="50" name="Rectangle 49"/>
              <p:cNvSpPr/>
              <p:nvPr/>
            </p:nvSpPr>
            <p:spPr>
              <a:xfrm>
                <a:off x="4563322" y="2845556"/>
                <a:ext cx="9757366" cy="57606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" name="Rectangle 50"/>
              <p:cNvSpPr/>
              <p:nvPr/>
            </p:nvSpPr>
            <p:spPr>
              <a:xfrm>
                <a:off x="4887640" y="2843808"/>
                <a:ext cx="8136904" cy="577812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" name="Rectangle 62"/>
              <p:cNvSpPr/>
              <p:nvPr/>
            </p:nvSpPr>
            <p:spPr>
              <a:xfrm>
                <a:off x="6975872" y="2843807"/>
                <a:ext cx="1008112" cy="577812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9" name="Group 8"/>
          <p:cNvGrpSpPr/>
          <p:nvPr/>
        </p:nvGrpSpPr>
        <p:grpSpPr>
          <a:xfrm>
            <a:off x="1882140" y="3244244"/>
            <a:ext cx="8858376" cy="577081"/>
            <a:chOff x="2509520" y="4356142"/>
            <a:chExt cx="11811168" cy="769441"/>
          </a:xfrm>
        </p:grpSpPr>
        <p:grpSp>
          <p:nvGrpSpPr>
            <p:cNvPr id="4" name="Group 3"/>
            <p:cNvGrpSpPr/>
            <p:nvPr/>
          </p:nvGrpSpPr>
          <p:grpSpPr>
            <a:xfrm>
              <a:off x="4563322" y="4436568"/>
              <a:ext cx="9757366" cy="577812"/>
              <a:chOff x="4563322" y="4436568"/>
              <a:chExt cx="9757366" cy="577812"/>
            </a:xfrm>
          </p:grpSpPr>
          <p:sp>
            <p:nvSpPr>
              <p:cNvPr id="55" name="Rectangle 54"/>
              <p:cNvSpPr/>
              <p:nvPr/>
            </p:nvSpPr>
            <p:spPr>
              <a:xfrm>
                <a:off x="4563322" y="4438316"/>
                <a:ext cx="9757366" cy="57606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" name="Rectangle 55"/>
              <p:cNvSpPr/>
              <p:nvPr/>
            </p:nvSpPr>
            <p:spPr>
              <a:xfrm>
                <a:off x="5463704" y="4436568"/>
                <a:ext cx="3816424" cy="577812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" name="Rectangle 56"/>
              <p:cNvSpPr/>
              <p:nvPr/>
            </p:nvSpPr>
            <p:spPr>
              <a:xfrm>
                <a:off x="6975872" y="4436568"/>
                <a:ext cx="1008112" cy="577812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64" name="TextBox 63"/>
            <p:cNvSpPr txBox="1"/>
            <p:nvPr/>
          </p:nvSpPr>
          <p:spPr>
            <a:xfrm>
              <a:off x="2509520" y="4356142"/>
              <a:ext cx="1949268" cy="769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rtl="0"/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Reduced secondary recombinant </a:t>
              </a:r>
            </a:p>
            <a:p>
              <a:pPr algn="ctr" rtl="0"/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(type b, R-18)</a:t>
              </a:r>
            </a:p>
          </p:txBody>
        </p:sp>
      </p:grpSp>
      <p:grpSp>
        <p:nvGrpSpPr>
          <p:cNvPr id="10" name="Group 9"/>
          <p:cNvGrpSpPr/>
          <p:nvPr/>
        </p:nvGrpSpPr>
        <p:grpSpPr>
          <a:xfrm>
            <a:off x="2137669" y="4101646"/>
            <a:ext cx="8602289" cy="435970"/>
            <a:chOff x="2850969" y="5298756"/>
            <a:chExt cx="11469719" cy="581293"/>
          </a:xfrm>
        </p:grpSpPr>
        <p:grpSp>
          <p:nvGrpSpPr>
            <p:cNvPr id="3" name="Group 2"/>
            <p:cNvGrpSpPr/>
            <p:nvPr/>
          </p:nvGrpSpPr>
          <p:grpSpPr>
            <a:xfrm>
              <a:off x="4563322" y="5298756"/>
              <a:ext cx="9757366" cy="577812"/>
              <a:chOff x="4563322" y="5298756"/>
              <a:chExt cx="9757366" cy="577812"/>
            </a:xfrm>
          </p:grpSpPr>
          <p:sp>
            <p:nvSpPr>
              <p:cNvPr id="58" name="Rectangle 57"/>
              <p:cNvSpPr/>
              <p:nvPr/>
            </p:nvSpPr>
            <p:spPr>
              <a:xfrm>
                <a:off x="4563322" y="5300504"/>
                <a:ext cx="9757366" cy="57606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" name="Rectangle 58"/>
              <p:cNvSpPr/>
              <p:nvPr/>
            </p:nvSpPr>
            <p:spPr>
              <a:xfrm>
                <a:off x="6975872" y="5298756"/>
                <a:ext cx="2304256" cy="577812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Rectangle 59"/>
              <p:cNvSpPr/>
              <p:nvPr/>
            </p:nvSpPr>
            <p:spPr>
              <a:xfrm>
                <a:off x="6975872" y="5298756"/>
                <a:ext cx="1008112" cy="577812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65" name="TextBox 64"/>
            <p:cNvSpPr txBox="1"/>
            <p:nvPr/>
          </p:nvSpPr>
          <p:spPr>
            <a:xfrm>
              <a:off x="2850969" y="5326052"/>
              <a:ext cx="1495685" cy="553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rtl="0"/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Tertiary </a:t>
              </a:r>
            </a:p>
            <a:p>
              <a:pPr algn="ctr" rtl="0"/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recombinant </a:t>
              </a:r>
            </a:p>
          </p:txBody>
        </p:sp>
      </p:grpSp>
      <p:grpSp>
        <p:nvGrpSpPr>
          <p:cNvPr id="12" name="Group 11"/>
          <p:cNvGrpSpPr/>
          <p:nvPr/>
        </p:nvGrpSpPr>
        <p:grpSpPr>
          <a:xfrm>
            <a:off x="1432560" y="972426"/>
            <a:ext cx="9937849" cy="253916"/>
            <a:chOff x="1142232" y="6832946"/>
            <a:chExt cx="13250464" cy="338555"/>
          </a:xfrm>
        </p:grpSpPr>
        <p:sp>
          <p:nvSpPr>
            <p:cNvPr id="75" name="TextBox 74"/>
            <p:cNvSpPr txBox="1"/>
            <p:nvPr/>
          </p:nvSpPr>
          <p:spPr>
            <a:xfrm>
              <a:off x="1142232" y="6832946"/>
              <a:ext cx="13250464" cy="3385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presentative recombinant </a:t>
              </a:r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chromosome </a:t>
              </a:r>
              <a:r>
                <a:rPr lang="en-US" sz="105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6B</a:t>
              </a:r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 constitution:  </a:t>
              </a:r>
              <a:r>
                <a:rPr lang="en-US" sz="105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Galil</a:t>
              </a:r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05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            </a:t>
              </a:r>
              <a:r>
                <a:rPr lang="en-US" sz="105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05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e. </a:t>
              </a:r>
              <a:r>
                <a:rPr lang="en-US" sz="1050" b="1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haronensis</a:t>
              </a:r>
              <a:r>
                <a:rPr lang="en-US" sz="105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- </a:t>
              </a:r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              Recombinant region present in all resistant </a:t>
              </a:r>
              <a:r>
                <a:rPr lang="en-US" sz="105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ines -  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Rectangle 10"/>
            <p:cNvSpPr/>
            <p:nvPr/>
          </p:nvSpPr>
          <p:spPr>
            <a:xfrm>
              <a:off x="6875359" y="6931503"/>
              <a:ext cx="288032" cy="14144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Rectangle 76"/>
            <p:cNvSpPr/>
            <p:nvPr/>
          </p:nvSpPr>
          <p:spPr>
            <a:xfrm>
              <a:off x="9022129" y="6931503"/>
              <a:ext cx="288032" cy="14144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Rectangle 77"/>
            <p:cNvSpPr/>
            <p:nvPr/>
          </p:nvSpPr>
          <p:spPr>
            <a:xfrm>
              <a:off x="13971743" y="6931499"/>
              <a:ext cx="288032" cy="141447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56636334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316</TotalTime>
  <Words>43</Words>
  <Application>Microsoft Office PowerPoint</Application>
  <PresentationFormat>Widescreen</PresentationFormat>
  <Paragraphs>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Tel Aviv Universit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na M</dc:creator>
  <cp:lastModifiedBy>Anna M</cp:lastModifiedBy>
  <cp:revision>9</cp:revision>
  <dcterms:created xsi:type="dcterms:W3CDTF">2019-03-31T09:30:16Z</dcterms:created>
  <dcterms:modified xsi:type="dcterms:W3CDTF">2019-09-03T12:24:37Z</dcterms:modified>
</cp:coreProperties>
</file>